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2AB9E20-885D-46E2-8376-B897CA17E291}" v="2" dt="2025-07-10T09:54:10.14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771" autoAdjust="0"/>
  </p:normalViewPr>
  <p:slideViewPr>
    <p:cSldViewPr snapToGrid="0">
      <p:cViewPr varScale="1">
        <p:scale>
          <a:sx n="74" d="100"/>
          <a:sy n="74" d="100"/>
        </p:scale>
        <p:origin x="101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engoa Luoni, Sofia" userId="0f006e73-fac7-47f0-8625-356df4b8922a" providerId="ADAL" clId="{5A0C2E49-5766-4C8D-BFBF-185C7DE873EC}"/>
    <pc:docChg chg="custSel modSld">
      <pc:chgData name="Bengoa Luoni, Sofia" userId="0f006e73-fac7-47f0-8625-356df4b8922a" providerId="ADAL" clId="{5A0C2E49-5766-4C8D-BFBF-185C7DE873EC}" dt="2025-05-18T15:15:02.631" v="125" actId="1076"/>
      <pc:docMkLst>
        <pc:docMk/>
      </pc:docMkLst>
      <pc:sldChg chg="addSp delSp modSp mod">
        <pc:chgData name="Bengoa Luoni, Sofia" userId="0f006e73-fac7-47f0-8625-356df4b8922a" providerId="ADAL" clId="{5A0C2E49-5766-4C8D-BFBF-185C7DE873EC}" dt="2025-05-18T15:15:02.631" v="125" actId="1076"/>
        <pc:sldMkLst>
          <pc:docMk/>
          <pc:sldMk cId="636206431" sldId="257"/>
        </pc:sldMkLst>
        <pc:spChg chg="del">
          <ac:chgData name="Bengoa Luoni, Sofia" userId="0f006e73-fac7-47f0-8625-356df4b8922a" providerId="ADAL" clId="{5A0C2E49-5766-4C8D-BFBF-185C7DE873EC}" dt="2025-05-18T14:58:12.145" v="2" actId="478"/>
          <ac:spMkLst>
            <pc:docMk/>
            <pc:sldMk cId="636206431" sldId="257"/>
            <ac:spMk id="6" creationId="{C56ECE3F-C089-3C1E-CA02-BB6159C80E1E}"/>
          </ac:spMkLst>
        </pc:spChg>
        <pc:spChg chg="del">
          <ac:chgData name="Bengoa Luoni, Sofia" userId="0f006e73-fac7-47f0-8625-356df4b8922a" providerId="ADAL" clId="{5A0C2E49-5766-4C8D-BFBF-185C7DE873EC}" dt="2025-05-18T14:58:12.145" v="2" actId="478"/>
          <ac:spMkLst>
            <pc:docMk/>
            <pc:sldMk cId="636206431" sldId="257"/>
            <ac:spMk id="8" creationId="{353E72DA-AC4F-0B8C-A162-E8D717FA40D3}"/>
          </ac:spMkLst>
        </pc:spChg>
        <pc:spChg chg="del">
          <ac:chgData name="Bengoa Luoni, Sofia" userId="0f006e73-fac7-47f0-8625-356df4b8922a" providerId="ADAL" clId="{5A0C2E49-5766-4C8D-BFBF-185C7DE873EC}" dt="2025-05-18T14:58:12.145" v="2" actId="478"/>
          <ac:spMkLst>
            <pc:docMk/>
            <pc:sldMk cId="636206431" sldId="257"/>
            <ac:spMk id="9" creationId="{B4FB4078-C614-62C1-7624-50475EF22213}"/>
          </ac:spMkLst>
        </pc:spChg>
        <pc:spChg chg="del">
          <ac:chgData name="Bengoa Luoni, Sofia" userId="0f006e73-fac7-47f0-8625-356df4b8922a" providerId="ADAL" clId="{5A0C2E49-5766-4C8D-BFBF-185C7DE873EC}" dt="2025-05-18T14:58:12.145" v="2" actId="478"/>
          <ac:spMkLst>
            <pc:docMk/>
            <pc:sldMk cId="636206431" sldId="257"/>
            <ac:spMk id="10" creationId="{D569BFE4-9C8A-46B7-AF7B-8E7F4DDB4763}"/>
          </ac:spMkLst>
        </pc:spChg>
        <pc:spChg chg="del">
          <ac:chgData name="Bengoa Luoni, Sofia" userId="0f006e73-fac7-47f0-8625-356df4b8922a" providerId="ADAL" clId="{5A0C2E49-5766-4C8D-BFBF-185C7DE873EC}" dt="2025-05-18T14:58:12.145" v="2" actId="478"/>
          <ac:spMkLst>
            <pc:docMk/>
            <pc:sldMk cId="636206431" sldId="257"/>
            <ac:spMk id="11" creationId="{D914861A-03DD-909F-83C7-1EFD1457D081}"/>
          </ac:spMkLst>
        </pc:spChg>
        <pc:spChg chg="del">
          <ac:chgData name="Bengoa Luoni, Sofia" userId="0f006e73-fac7-47f0-8625-356df4b8922a" providerId="ADAL" clId="{5A0C2E49-5766-4C8D-BFBF-185C7DE873EC}" dt="2025-05-18T14:58:12.145" v="2" actId="478"/>
          <ac:spMkLst>
            <pc:docMk/>
            <pc:sldMk cId="636206431" sldId="257"/>
            <ac:spMk id="12" creationId="{EEE781AB-7588-BD88-8AAB-E4B0B61F4695}"/>
          </ac:spMkLst>
        </pc:spChg>
        <pc:picChg chg="del">
          <ac:chgData name="Bengoa Luoni, Sofia" userId="0f006e73-fac7-47f0-8625-356df4b8922a" providerId="ADAL" clId="{5A0C2E49-5766-4C8D-BFBF-185C7DE873EC}" dt="2025-05-18T14:58:10.774" v="1" actId="478"/>
          <ac:picMkLst>
            <pc:docMk/>
            <pc:sldMk cId="636206431" sldId="257"/>
            <ac:picMk id="3" creationId="{FC6C1FB2-5DA9-3FF9-97AC-D60DECFB48A2}"/>
          </ac:picMkLst>
        </pc:picChg>
        <pc:picChg chg="add del mod">
          <ac:chgData name="Bengoa Luoni, Sofia" userId="0f006e73-fac7-47f0-8625-356df4b8922a" providerId="ADAL" clId="{5A0C2E49-5766-4C8D-BFBF-185C7DE873EC}" dt="2025-05-18T15:00:13.915" v="66" actId="478"/>
          <ac:picMkLst>
            <pc:docMk/>
            <pc:sldMk cId="636206431" sldId="257"/>
            <ac:picMk id="4" creationId="{D2F9CA4F-DF2A-1730-2E1B-9029571787F5}"/>
          </ac:picMkLst>
        </pc:picChg>
        <pc:picChg chg="del">
          <ac:chgData name="Bengoa Luoni, Sofia" userId="0f006e73-fac7-47f0-8625-356df4b8922a" providerId="ADAL" clId="{5A0C2E49-5766-4C8D-BFBF-185C7DE873EC}" dt="2025-05-18T14:58:10.093" v="0" actId="478"/>
          <ac:picMkLst>
            <pc:docMk/>
            <pc:sldMk cId="636206431" sldId="257"/>
            <ac:picMk id="5" creationId="{85DC8C07-727A-1CCD-8873-09EFE5C71453}"/>
          </ac:picMkLst>
        </pc:picChg>
        <pc:picChg chg="add del mod">
          <ac:chgData name="Bengoa Luoni, Sofia" userId="0f006e73-fac7-47f0-8625-356df4b8922a" providerId="ADAL" clId="{5A0C2E49-5766-4C8D-BFBF-185C7DE873EC}" dt="2025-05-18T15:00:13.915" v="66" actId="478"/>
          <ac:picMkLst>
            <pc:docMk/>
            <pc:sldMk cId="636206431" sldId="257"/>
            <ac:picMk id="13" creationId="{33997D07-97BA-A3A2-A825-69C1413A8022}"/>
          </ac:picMkLst>
        </pc:picChg>
        <pc:picChg chg="add del mod">
          <ac:chgData name="Bengoa Luoni, Sofia" userId="0f006e73-fac7-47f0-8625-356df4b8922a" providerId="ADAL" clId="{5A0C2E49-5766-4C8D-BFBF-185C7DE873EC}" dt="2025-05-18T15:00:13.915" v="66" actId="478"/>
          <ac:picMkLst>
            <pc:docMk/>
            <pc:sldMk cId="636206431" sldId="257"/>
            <ac:picMk id="15" creationId="{5308008D-58C8-1C49-E006-BBA22AB963FF}"/>
          </ac:picMkLst>
        </pc:picChg>
        <pc:picChg chg="add del mod">
          <ac:chgData name="Bengoa Luoni, Sofia" userId="0f006e73-fac7-47f0-8625-356df4b8922a" providerId="ADAL" clId="{5A0C2E49-5766-4C8D-BFBF-185C7DE873EC}" dt="2025-05-18T15:00:13.915" v="66" actId="478"/>
          <ac:picMkLst>
            <pc:docMk/>
            <pc:sldMk cId="636206431" sldId="257"/>
            <ac:picMk id="17" creationId="{3C93A9EE-E4B9-0DE0-0BEA-65031F6F5006}"/>
          </ac:picMkLst>
        </pc:picChg>
        <pc:picChg chg="add del mod">
          <ac:chgData name="Bengoa Luoni, Sofia" userId="0f006e73-fac7-47f0-8625-356df4b8922a" providerId="ADAL" clId="{5A0C2E49-5766-4C8D-BFBF-185C7DE873EC}" dt="2025-05-18T15:00:13.915" v="66" actId="478"/>
          <ac:picMkLst>
            <pc:docMk/>
            <pc:sldMk cId="636206431" sldId="257"/>
            <ac:picMk id="19" creationId="{8AEC6776-4741-202F-6242-4ED3A61EC819}"/>
          </ac:picMkLst>
        </pc:picChg>
        <pc:picChg chg="add del mod">
          <ac:chgData name="Bengoa Luoni, Sofia" userId="0f006e73-fac7-47f0-8625-356df4b8922a" providerId="ADAL" clId="{5A0C2E49-5766-4C8D-BFBF-185C7DE873EC}" dt="2025-05-18T15:00:13.915" v="66" actId="478"/>
          <ac:picMkLst>
            <pc:docMk/>
            <pc:sldMk cId="636206431" sldId="257"/>
            <ac:picMk id="21" creationId="{71555FFC-AC69-4886-FAD7-7478E8B52FF3}"/>
          </ac:picMkLst>
        </pc:picChg>
        <pc:picChg chg="add del mod">
          <ac:chgData name="Bengoa Luoni, Sofia" userId="0f006e73-fac7-47f0-8625-356df4b8922a" providerId="ADAL" clId="{5A0C2E49-5766-4C8D-BFBF-185C7DE873EC}" dt="2025-05-18T15:00:15.020" v="67" actId="478"/>
          <ac:picMkLst>
            <pc:docMk/>
            <pc:sldMk cId="636206431" sldId="257"/>
            <ac:picMk id="23" creationId="{24994A43-17BF-A943-405B-30C0FB56461C}"/>
          </ac:picMkLst>
        </pc:picChg>
        <pc:picChg chg="add del mod">
          <ac:chgData name="Bengoa Luoni, Sofia" userId="0f006e73-fac7-47f0-8625-356df4b8922a" providerId="ADAL" clId="{5A0C2E49-5766-4C8D-BFBF-185C7DE873EC}" dt="2025-05-18T15:00:13.915" v="66" actId="478"/>
          <ac:picMkLst>
            <pc:docMk/>
            <pc:sldMk cId="636206431" sldId="257"/>
            <ac:picMk id="25" creationId="{B56770E3-EC85-DCBF-CF89-3F1D8F67887B}"/>
          </ac:picMkLst>
        </pc:picChg>
        <pc:picChg chg="add del mod">
          <ac:chgData name="Bengoa Luoni, Sofia" userId="0f006e73-fac7-47f0-8625-356df4b8922a" providerId="ADAL" clId="{5A0C2E49-5766-4C8D-BFBF-185C7DE873EC}" dt="2025-05-18T15:00:13.915" v="66" actId="478"/>
          <ac:picMkLst>
            <pc:docMk/>
            <pc:sldMk cId="636206431" sldId="257"/>
            <ac:picMk id="27" creationId="{01E5AAF0-CCFE-807E-4114-545E863233E9}"/>
          </ac:picMkLst>
        </pc:picChg>
        <pc:picChg chg="add del mod">
          <ac:chgData name="Bengoa Luoni, Sofia" userId="0f006e73-fac7-47f0-8625-356df4b8922a" providerId="ADAL" clId="{5A0C2E49-5766-4C8D-BFBF-185C7DE873EC}" dt="2025-05-18T15:00:13.915" v="66" actId="478"/>
          <ac:picMkLst>
            <pc:docMk/>
            <pc:sldMk cId="636206431" sldId="257"/>
            <ac:picMk id="29" creationId="{6A1FF851-42B4-C8E3-9C9F-63B362C57A8B}"/>
          </ac:picMkLst>
        </pc:picChg>
        <pc:picChg chg="add del mod">
          <ac:chgData name="Bengoa Luoni, Sofia" userId="0f006e73-fac7-47f0-8625-356df4b8922a" providerId="ADAL" clId="{5A0C2E49-5766-4C8D-BFBF-185C7DE873EC}" dt="2025-05-18T15:00:13.915" v="66" actId="478"/>
          <ac:picMkLst>
            <pc:docMk/>
            <pc:sldMk cId="636206431" sldId="257"/>
            <ac:picMk id="31" creationId="{CFC7C480-BBBF-5CA6-6309-D01E43BE1C87}"/>
          </ac:picMkLst>
        </pc:picChg>
        <pc:picChg chg="add del mod">
          <ac:chgData name="Bengoa Luoni, Sofia" userId="0f006e73-fac7-47f0-8625-356df4b8922a" providerId="ADAL" clId="{5A0C2E49-5766-4C8D-BFBF-185C7DE873EC}" dt="2025-05-18T15:00:13.915" v="66" actId="478"/>
          <ac:picMkLst>
            <pc:docMk/>
            <pc:sldMk cId="636206431" sldId="257"/>
            <ac:picMk id="33" creationId="{1A034BAB-DB2F-F241-155E-6340E95B6F84}"/>
          </ac:picMkLst>
        </pc:picChg>
        <pc:picChg chg="add del mod">
          <ac:chgData name="Bengoa Luoni, Sofia" userId="0f006e73-fac7-47f0-8625-356df4b8922a" providerId="ADAL" clId="{5A0C2E49-5766-4C8D-BFBF-185C7DE873EC}" dt="2025-05-18T14:59:12.652" v="57" actId="478"/>
          <ac:picMkLst>
            <pc:docMk/>
            <pc:sldMk cId="636206431" sldId="257"/>
            <ac:picMk id="35" creationId="{56B82496-C694-9635-94BD-B051009589F1}"/>
          </ac:picMkLst>
        </pc:picChg>
        <pc:picChg chg="add del mod">
          <ac:chgData name="Bengoa Luoni, Sofia" userId="0f006e73-fac7-47f0-8625-356df4b8922a" providerId="ADAL" clId="{5A0C2E49-5766-4C8D-BFBF-185C7DE873EC}" dt="2025-05-18T14:59:12.196" v="56" actId="478"/>
          <ac:picMkLst>
            <pc:docMk/>
            <pc:sldMk cId="636206431" sldId="257"/>
            <ac:picMk id="37" creationId="{B6F27DC4-2B5A-10AB-5270-A3390E14E4D9}"/>
          </ac:picMkLst>
        </pc:picChg>
        <pc:picChg chg="add del mod">
          <ac:chgData name="Bengoa Luoni, Sofia" userId="0f006e73-fac7-47f0-8625-356df4b8922a" providerId="ADAL" clId="{5A0C2E49-5766-4C8D-BFBF-185C7DE873EC}" dt="2025-05-18T14:59:11.691" v="55" actId="478"/>
          <ac:picMkLst>
            <pc:docMk/>
            <pc:sldMk cId="636206431" sldId="257"/>
            <ac:picMk id="39" creationId="{C06EA48F-19DC-22B8-D436-2DA35805970B}"/>
          </ac:picMkLst>
        </pc:picChg>
        <pc:picChg chg="add del mod">
          <ac:chgData name="Bengoa Luoni, Sofia" userId="0f006e73-fac7-47f0-8625-356df4b8922a" providerId="ADAL" clId="{5A0C2E49-5766-4C8D-BFBF-185C7DE873EC}" dt="2025-05-18T14:59:11.126" v="54" actId="478"/>
          <ac:picMkLst>
            <pc:docMk/>
            <pc:sldMk cId="636206431" sldId="257"/>
            <ac:picMk id="41" creationId="{A815B70F-0C90-0F29-DF5D-2D7D86704379}"/>
          </ac:picMkLst>
        </pc:picChg>
        <pc:picChg chg="add del mod">
          <ac:chgData name="Bengoa Luoni, Sofia" userId="0f006e73-fac7-47f0-8625-356df4b8922a" providerId="ADAL" clId="{5A0C2E49-5766-4C8D-BFBF-185C7DE873EC}" dt="2025-05-18T14:59:10.636" v="53" actId="478"/>
          <ac:picMkLst>
            <pc:docMk/>
            <pc:sldMk cId="636206431" sldId="257"/>
            <ac:picMk id="43" creationId="{10139E22-30C8-1365-DCC4-18DEF8F15B39}"/>
          </ac:picMkLst>
        </pc:picChg>
        <pc:picChg chg="add del mod">
          <ac:chgData name="Bengoa Luoni, Sofia" userId="0f006e73-fac7-47f0-8625-356df4b8922a" providerId="ADAL" clId="{5A0C2E49-5766-4C8D-BFBF-185C7DE873EC}" dt="2025-05-18T14:59:10.102" v="52" actId="478"/>
          <ac:picMkLst>
            <pc:docMk/>
            <pc:sldMk cId="636206431" sldId="257"/>
            <ac:picMk id="45" creationId="{9922E1C3-72D3-1739-53BD-9CD7B87379C6}"/>
          </ac:picMkLst>
        </pc:picChg>
        <pc:picChg chg="add del mod">
          <ac:chgData name="Bengoa Luoni, Sofia" userId="0f006e73-fac7-47f0-8625-356df4b8922a" providerId="ADAL" clId="{5A0C2E49-5766-4C8D-BFBF-185C7DE873EC}" dt="2025-05-18T14:59:09.425" v="51" actId="478"/>
          <ac:picMkLst>
            <pc:docMk/>
            <pc:sldMk cId="636206431" sldId="257"/>
            <ac:picMk id="47" creationId="{BA8871E7-F035-E962-8F74-91D15623B502}"/>
          </ac:picMkLst>
        </pc:picChg>
        <pc:picChg chg="add del mod">
          <ac:chgData name="Bengoa Luoni, Sofia" userId="0f006e73-fac7-47f0-8625-356df4b8922a" providerId="ADAL" clId="{5A0C2E49-5766-4C8D-BFBF-185C7DE873EC}" dt="2025-05-18T14:59:08.810" v="50" actId="478"/>
          <ac:picMkLst>
            <pc:docMk/>
            <pc:sldMk cId="636206431" sldId="257"/>
            <ac:picMk id="49" creationId="{9C184097-4216-F4A3-B24C-E9ADCDACDAF4}"/>
          </ac:picMkLst>
        </pc:picChg>
        <pc:picChg chg="add del mod">
          <ac:chgData name="Bengoa Luoni, Sofia" userId="0f006e73-fac7-47f0-8625-356df4b8922a" providerId="ADAL" clId="{5A0C2E49-5766-4C8D-BFBF-185C7DE873EC}" dt="2025-05-18T14:59:08.147" v="49" actId="478"/>
          <ac:picMkLst>
            <pc:docMk/>
            <pc:sldMk cId="636206431" sldId="257"/>
            <ac:picMk id="51" creationId="{8AAF3DC6-08F4-6524-426A-107D0F149AB9}"/>
          </ac:picMkLst>
        </pc:picChg>
        <pc:picChg chg="add mod">
          <ac:chgData name="Bengoa Luoni, Sofia" userId="0f006e73-fac7-47f0-8625-356df4b8922a" providerId="ADAL" clId="{5A0C2E49-5766-4C8D-BFBF-185C7DE873EC}" dt="2025-05-18T15:14:57.514" v="123" actId="1076"/>
          <ac:picMkLst>
            <pc:docMk/>
            <pc:sldMk cId="636206431" sldId="257"/>
            <ac:picMk id="53" creationId="{9772AC92-B40E-8A86-87D6-65DBFFD6A1EC}"/>
          </ac:picMkLst>
        </pc:picChg>
        <pc:picChg chg="add mod">
          <ac:chgData name="Bengoa Luoni, Sofia" userId="0f006e73-fac7-47f0-8625-356df4b8922a" providerId="ADAL" clId="{5A0C2E49-5766-4C8D-BFBF-185C7DE873EC}" dt="2025-05-18T15:15:01.289" v="124" actId="1076"/>
          <ac:picMkLst>
            <pc:docMk/>
            <pc:sldMk cId="636206431" sldId="257"/>
            <ac:picMk id="55" creationId="{C4D3F5A1-A61E-2D27-778D-48D738AAB596}"/>
          </ac:picMkLst>
        </pc:picChg>
        <pc:picChg chg="add mod">
          <ac:chgData name="Bengoa Luoni, Sofia" userId="0f006e73-fac7-47f0-8625-356df4b8922a" providerId="ADAL" clId="{5A0C2E49-5766-4C8D-BFBF-185C7DE873EC}" dt="2025-05-18T15:15:02.631" v="125" actId="1076"/>
          <ac:picMkLst>
            <pc:docMk/>
            <pc:sldMk cId="636206431" sldId="257"/>
            <ac:picMk id="57" creationId="{6DECB1F6-6CCE-D0AE-B0C6-04F4D9300F41}"/>
          </ac:picMkLst>
        </pc:picChg>
        <pc:picChg chg="add mod">
          <ac:chgData name="Bengoa Luoni, Sofia" userId="0f006e73-fac7-47f0-8625-356df4b8922a" providerId="ADAL" clId="{5A0C2E49-5766-4C8D-BFBF-185C7DE873EC}" dt="2025-05-18T15:14:40.965" v="116" actId="1076"/>
          <ac:picMkLst>
            <pc:docMk/>
            <pc:sldMk cId="636206431" sldId="257"/>
            <ac:picMk id="59" creationId="{315E27D0-E120-ADC4-53A7-4096E10C2514}"/>
          </ac:picMkLst>
        </pc:picChg>
        <pc:picChg chg="add mod">
          <ac:chgData name="Bengoa Luoni, Sofia" userId="0f006e73-fac7-47f0-8625-356df4b8922a" providerId="ADAL" clId="{5A0C2E49-5766-4C8D-BFBF-185C7DE873EC}" dt="2025-05-18T15:14:44.052" v="117" actId="1076"/>
          <ac:picMkLst>
            <pc:docMk/>
            <pc:sldMk cId="636206431" sldId="257"/>
            <ac:picMk id="61" creationId="{8BC64586-FEDF-C21D-19E0-11A1F7A29B6E}"/>
          </ac:picMkLst>
        </pc:picChg>
        <pc:picChg chg="add mod">
          <ac:chgData name="Bengoa Luoni, Sofia" userId="0f006e73-fac7-47f0-8625-356df4b8922a" providerId="ADAL" clId="{5A0C2E49-5766-4C8D-BFBF-185C7DE873EC}" dt="2025-05-18T15:14:46.055" v="118" actId="1076"/>
          <ac:picMkLst>
            <pc:docMk/>
            <pc:sldMk cId="636206431" sldId="257"/>
            <ac:picMk id="63" creationId="{3E4F057E-FFEF-DF29-057C-9143B848AA6D}"/>
          </ac:picMkLst>
        </pc:picChg>
        <pc:picChg chg="add mod">
          <ac:chgData name="Bengoa Luoni, Sofia" userId="0f006e73-fac7-47f0-8625-356df4b8922a" providerId="ADAL" clId="{5A0C2E49-5766-4C8D-BFBF-185C7DE873EC}" dt="2025-05-18T15:14:37.574" v="115" actId="1076"/>
          <ac:picMkLst>
            <pc:docMk/>
            <pc:sldMk cId="636206431" sldId="257"/>
            <ac:picMk id="65" creationId="{3E4B4DF0-29DD-8B7A-A419-B7AD5533D13F}"/>
          </ac:picMkLst>
        </pc:picChg>
        <pc:picChg chg="add mod">
          <ac:chgData name="Bengoa Luoni, Sofia" userId="0f006e73-fac7-47f0-8625-356df4b8922a" providerId="ADAL" clId="{5A0C2E49-5766-4C8D-BFBF-185C7DE873EC}" dt="2025-05-18T15:14:34.364" v="114" actId="1076"/>
          <ac:picMkLst>
            <pc:docMk/>
            <pc:sldMk cId="636206431" sldId="257"/>
            <ac:picMk id="67" creationId="{02F78032-06D8-59CF-64D1-F94BD84FD7D4}"/>
          </ac:picMkLst>
        </pc:picChg>
        <pc:picChg chg="add del mod">
          <ac:chgData name="Bengoa Luoni, Sofia" userId="0f006e73-fac7-47f0-8625-356df4b8922a" providerId="ADAL" clId="{5A0C2E49-5766-4C8D-BFBF-185C7DE873EC}" dt="2025-05-18T15:12:13.525" v="106" actId="478"/>
          <ac:picMkLst>
            <pc:docMk/>
            <pc:sldMk cId="636206431" sldId="257"/>
            <ac:picMk id="69" creationId="{DD978A76-EB5D-1A93-66A5-B934F869B5E7}"/>
          </ac:picMkLst>
        </pc:picChg>
        <pc:picChg chg="add mod">
          <ac:chgData name="Bengoa Luoni, Sofia" userId="0f006e73-fac7-47f0-8625-356df4b8922a" providerId="ADAL" clId="{5A0C2E49-5766-4C8D-BFBF-185C7DE873EC}" dt="2025-05-18T15:14:27.918" v="112" actId="1076"/>
          <ac:picMkLst>
            <pc:docMk/>
            <pc:sldMk cId="636206431" sldId="257"/>
            <ac:picMk id="71" creationId="{561A4C62-9D59-0ACC-8D5A-0BE94500B752}"/>
          </ac:picMkLst>
        </pc:picChg>
      </pc:sldChg>
    </pc:docChg>
  </pc:docChgLst>
  <pc:docChgLst>
    <pc:chgData name="Bengoa Luoni, Sofia" userId="0f006e73-fac7-47f0-8625-356df4b8922a" providerId="ADAL" clId="{2C0E25E5-DBE1-41EF-A810-7B452E6A22CA}"/>
    <pc:docChg chg="custSel addSld modSld sldOrd">
      <pc:chgData name="Bengoa Luoni, Sofia" userId="0f006e73-fac7-47f0-8625-356df4b8922a" providerId="ADAL" clId="{2C0E25E5-DBE1-41EF-A810-7B452E6A22CA}" dt="2025-05-23T08:01:09.249" v="484" actId="20577"/>
      <pc:docMkLst>
        <pc:docMk/>
      </pc:docMkLst>
      <pc:sldChg chg="addSp delSp modSp mod">
        <pc:chgData name="Bengoa Luoni, Sofia" userId="0f006e73-fac7-47f0-8625-356df4b8922a" providerId="ADAL" clId="{2C0E25E5-DBE1-41EF-A810-7B452E6A22CA}" dt="2025-05-23T08:01:09.249" v="484" actId="20577"/>
        <pc:sldMkLst>
          <pc:docMk/>
          <pc:sldMk cId="636206431" sldId="257"/>
        </pc:sldMkLst>
        <pc:spChg chg="add del mod">
          <ac:chgData name="Bengoa Luoni, Sofia" userId="0f006e73-fac7-47f0-8625-356df4b8922a" providerId="ADAL" clId="{2C0E25E5-DBE1-41EF-A810-7B452E6A22CA}" dt="2025-05-23T07:59:31.108" v="453" actId="478"/>
          <ac:spMkLst>
            <pc:docMk/>
            <pc:sldMk cId="636206431" sldId="257"/>
            <ac:spMk id="2" creationId="{7BBBB709-B064-0273-C3C3-6DC1CA73B643}"/>
          </ac:spMkLst>
        </pc:spChg>
        <pc:spChg chg="add mod">
          <ac:chgData name="Bengoa Luoni, Sofia" userId="0f006e73-fac7-47f0-8625-356df4b8922a" providerId="ADAL" clId="{2C0E25E5-DBE1-41EF-A810-7B452E6A22CA}" dt="2025-05-23T08:01:09.249" v="484" actId="20577"/>
          <ac:spMkLst>
            <pc:docMk/>
            <pc:sldMk cId="636206431" sldId="257"/>
            <ac:spMk id="4" creationId="{3B91AD48-56EB-9565-9291-100FE67E9656}"/>
          </ac:spMkLst>
        </pc:spChg>
        <pc:picChg chg="mod">
          <ac:chgData name="Bengoa Luoni, Sofia" userId="0f006e73-fac7-47f0-8625-356df4b8922a" providerId="ADAL" clId="{2C0E25E5-DBE1-41EF-A810-7B452E6A22CA}" dt="2025-05-23T08:00:40.890" v="478" actId="1076"/>
          <ac:picMkLst>
            <pc:docMk/>
            <pc:sldMk cId="636206431" sldId="257"/>
            <ac:picMk id="53" creationId="{9772AC92-B40E-8A86-87D6-65DBFFD6A1EC}"/>
          </ac:picMkLst>
        </pc:picChg>
        <pc:picChg chg="mod">
          <ac:chgData name="Bengoa Luoni, Sofia" userId="0f006e73-fac7-47f0-8625-356df4b8922a" providerId="ADAL" clId="{2C0E25E5-DBE1-41EF-A810-7B452E6A22CA}" dt="2025-05-23T08:00:35.085" v="476" actId="1076"/>
          <ac:picMkLst>
            <pc:docMk/>
            <pc:sldMk cId="636206431" sldId="257"/>
            <ac:picMk id="55" creationId="{C4D3F5A1-A61E-2D27-778D-48D738AAB596}"/>
          </ac:picMkLst>
        </pc:picChg>
        <pc:picChg chg="mod">
          <ac:chgData name="Bengoa Luoni, Sofia" userId="0f006e73-fac7-47f0-8625-356df4b8922a" providerId="ADAL" clId="{2C0E25E5-DBE1-41EF-A810-7B452E6A22CA}" dt="2025-05-23T08:00:37.086" v="477" actId="1076"/>
          <ac:picMkLst>
            <pc:docMk/>
            <pc:sldMk cId="636206431" sldId="257"/>
            <ac:picMk id="57" creationId="{6DECB1F6-6CCE-D0AE-B0C6-04F4D9300F41}"/>
          </ac:picMkLst>
        </pc:picChg>
        <pc:picChg chg="mod">
          <ac:chgData name="Bengoa Luoni, Sofia" userId="0f006e73-fac7-47f0-8625-356df4b8922a" providerId="ADAL" clId="{2C0E25E5-DBE1-41EF-A810-7B452E6A22CA}" dt="2025-05-23T08:00:10.800" v="468" actId="1076"/>
          <ac:picMkLst>
            <pc:docMk/>
            <pc:sldMk cId="636206431" sldId="257"/>
            <ac:picMk id="59" creationId="{315E27D0-E120-ADC4-53A7-4096E10C2514}"/>
          </ac:picMkLst>
        </pc:picChg>
        <pc:picChg chg="mod">
          <ac:chgData name="Bengoa Luoni, Sofia" userId="0f006e73-fac7-47f0-8625-356df4b8922a" providerId="ADAL" clId="{2C0E25E5-DBE1-41EF-A810-7B452E6A22CA}" dt="2025-05-23T08:00:04.381" v="466" actId="1076"/>
          <ac:picMkLst>
            <pc:docMk/>
            <pc:sldMk cId="636206431" sldId="257"/>
            <ac:picMk id="61" creationId="{8BC64586-FEDF-C21D-19E0-11A1F7A29B6E}"/>
          </ac:picMkLst>
        </pc:picChg>
        <pc:picChg chg="mod">
          <ac:chgData name="Bengoa Luoni, Sofia" userId="0f006e73-fac7-47f0-8625-356df4b8922a" providerId="ADAL" clId="{2C0E25E5-DBE1-41EF-A810-7B452E6A22CA}" dt="2025-05-23T08:00:05.660" v="467" actId="1076"/>
          <ac:picMkLst>
            <pc:docMk/>
            <pc:sldMk cId="636206431" sldId="257"/>
            <ac:picMk id="63" creationId="{3E4F057E-FFEF-DF29-057C-9143B848AA6D}"/>
          </ac:picMkLst>
        </pc:picChg>
        <pc:picChg chg="mod">
          <ac:chgData name="Bengoa Luoni, Sofia" userId="0f006e73-fac7-47f0-8625-356df4b8922a" providerId="ADAL" clId="{2C0E25E5-DBE1-41EF-A810-7B452E6A22CA}" dt="2025-05-23T07:59:52.855" v="462" actId="1076"/>
          <ac:picMkLst>
            <pc:docMk/>
            <pc:sldMk cId="636206431" sldId="257"/>
            <ac:picMk id="65" creationId="{3E4B4DF0-29DD-8B7A-A419-B7AD5533D13F}"/>
          </ac:picMkLst>
        </pc:picChg>
        <pc:picChg chg="mod">
          <ac:chgData name="Bengoa Luoni, Sofia" userId="0f006e73-fac7-47f0-8625-356df4b8922a" providerId="ADAL" clId="{2C0E25E5-DBE1-41EF-A810-7B452E6A22CA}" dt="2025-05-23T07:59:50.320" v="461" actId="1076"/>
          <ac:picMkLst>
            <pc:docMk/>
            <pc:sldMk cId="636206431" sldId="257"/>
            <ac:picMk id="67" creationId="{02F78032-06D8-59CF-64D1-F94BD84FD7D4}"/>
          </ac:picMkLst>
        </pc:picChg>
        <pc:picChg chg="mod">
          <ac:chgData name="Bengoa Luoni, Sofia" userId="0f006e73-fac7-47f0-8625-356df4b8922a" providerId="ADAL" clId="{2C0E25E5-DBE1-41EF-A810-7B452E6A22CA}" dt="2025-05-23T07:59:48.487" v="460" actId="1076"/>
          <ac:picMkLst>
            <pc:docMk/>
            <pc:sldMk cId="636206431" sldId="257"/>
            <ac:picMk id="71" creationId="{561A4C62-9D59-0ACC-8D5A-0BE94500B752}"/>
          </ac:picMkLst>
        </pc:picChg>
      </pc:sldChg>
      <pc:sldChg chg="addSp delSp modSp new mod ord">
        <pc:chgData name="Bengoa Luoni, Sofia" userId="0f006e73-fac7-47f0-8625-356df4b8922a" providerId="ADAL" clId="{2C0E25E5-DBE1-41EF-A810-7B452E6A22CA}" dt="2025-05-23T07:59:17.152" v="452" actId="6549"/>
        <pc:sldMkLst>
          <pc:docMk/>
          <pc:sldMk cId="2649116898" sldId="258"/>
        </pc:sldMkLst>
        <pc:spChg chg="add del mod">
          <ac:chgData name="Bengoa Luoni, Sofia" userId="0f006e73-fac7-47f0-8625-356df4b8922a" providerId="ADAL" clId="{2C0E25E5-DBE1-41EF-A810-7B452E6A22CA}" dt="2025-05-23T07:51:20.492" v="66" actId="478"/>
          <ac:spMkLst>
            <pc:docMk/>
            <pc:sldMk cId="2649116898" sldId="258"/>
            <ac:spMk id="2" creationId="{3B301FAA-C9C1-F037-669B-3F99968E8A92}"/>
          </ac:spMkLst>
        </pc:spChg>
        <pc:spChg chg="add mod">
          <ac:chgData name="Bengoa Luoni, Sofia" userId="0f006e73-fac7-47f0-8625-356df4b8922a" providerId="ADAL" clId="{2C0E25E5-DBE1-41EF-A810-7B452E6A22CA}" dt="2025-05-23T07:59:17.152" v="452" actId="6549"/>
          <ac:spMkLst>
            <pc:docMk/>
            <pc:sldMk cId="2649116898" sldId="258"/>
            <ac:spMk id="5" creationId="{A1A6CA4C-A339-5FC9-39F4-F74FDA49A3CC}"/>
          </ac:spMkLst>
        </pc:spChg>
        <pc:picChg chg="add mod">
          <ac:chgData name="Bengoa Luoni, Sofia" userId="0f006e73-fac7-47f0-8625-356df4b8922a" providerId="ADAL" clId="{2C0E25E5-DBE1-41EF-A810-7B452E6A22CA}" dt="2025-05-23T07:52:08.159" v="79" actId="1076"/>
          <ac:picMkLst>
            <pc:docMk/>
            <pc:sldMk cId="2649116898" sldId="258"/>
            <ac:picMk id="4" creationId="{FFD56AC1-1F6D-BFBF-022D-D6D0BDEBEAAE}"/>
          </ac:picMkLst>
        </pc:picChg>
        <pc:picChg chg="add mod">
          <ac:chgData name="Bengoa Luoni, Sofia" userId="0f006e73-fac7-47f0-8625-356df4b8922a" providerId="ADAL" clId="{2C0E25E5-DBE1-41EF-A810-7B452E6A22CA}" dt="2025-05-23T07:52:04.103" v="77" actId="1076"/>
          <ac:picMkLst>
            <pc:docMk/>
            <pc:sldMk cId="2649116898" sldId="258"/>
            <ac:picMk id="6" creationId="{056CAF1E-EE94-1A2C-5518-7607D7C3D103}"/>
          </ac:picMkLst>
        </pc:picChg>
        <pc:picChg chg="add mod">
          <ac:chgData name="Bengoa Luoni, Sofia" userId="0f006e73-fac7-47f0-8625-356df4b8922a" providerId="ADAL" clId="{2C0E25E5-DBE1-41EF-A810-7B452E6A22CA}" dt="2025-05-23T07:52:05.983" v="78" actId="1076"/>
          <ac:picMkLst>
            <pc:docMk/>
            <pc:sldMk cId="2649116898" sldId="258"/>
            <ac:picMk id="8" creationId="{80FDA6A6-3E8A-64B0-35A3-FBD2F13FC50E}"/>
          </ac:picMkLst>
        </pc:picChg>
        <pc:picChg chg="add del mod">
          <ac:chgData name="Bengoa Luoni, Sofia" userId="0f006e73-fac7-47f0-8625-356df4b8922a" providerId="ADAL" clId="{2C0E25E5-DBE1-41EF-A810-7B452E6A22CA}" dt="2025-05-18T17:11:53.468" v="47" actId="478"/>
          <ac:picMkLst>
            <pc:docMk/>
            <pc:sldMk cId="2649116898" sldId="258"/>
            <ac:picMk id="10" creationId="{DFF349B8-69A2-8737-152F-B15B05CD4512}"/>
          </ac:picMkLst>
        </pc:picChg>
        <pc:picChg chg="add del mod">
          <ac:chgData name="Bengoa Luoni, Sofia" userId="0f006e73-fac7-47f0-8625-356df4b8922a" providerId="ADAL" clId="{2C0E25E5-DBE1-41EF-A810-7B452E6A22CA}" dt="2025-05-18T17:11:54.208" v="48" actId="478"/>
          <ac:picMkLst>
            <pc:docMk/>
            <pc:sldMk cId="2649116898" sldId="258"/>
            <ac:picMk id="12" creationId="{F834D9B3-AD38-6D41-0B96-FB72525BE2ED}"/>
          </ac:picMkLst>
        </pc:picChg>
        <pc:picChg chg="add del mod">
          <ac:chgData name="Bengoa Luoni, Sofia" userId="0f006e73-fac7-47f0-8625-356df4b8922a" providerId="ADAL" clId="{2C0E25E5-DBE1-41EF-A810-7B452E6A22CA}" dt="2025-05-18T17:11:56.143" v="49" actId="478"/>
          <ac:picMkLst>
            <pc:docMk/>
            <pc:sldMk cId="2649116898" sldId="258"/>
            <ac:picMk id="14" creationId="{F6E81C89-5CFC-79A8-F872-591602AE5F23}"/>
          </ac:picMkLst>
        </pc:picChg>
        <pc:picChg chg="add mod">
          <ac:chgData name="Bengoa Luoni, Sofia" userId="0f006e73-fac7-47f0-8625-356df4b8922a" providerId="ADAL" clId="{2C0E25E5-DBE1-41EF-A810-7B452E6A22CA}" dt="2025-05-23T07:51:44.738" v="72" actId="1076"/>
          <ac:picMkLst>
            <pc:docMk/>
            <pc:sldMk cId="2649116898" sldId="258"/>
            <ac:picMk id="16" creationId="{515631D5-4341-1EDF-B2D2-66C262596207}"/>
          </ac:picMkLst>
        </pc:picChg>
        <pc:picChg chg="add mod">
          <ac:chgData name="Bengoa Luoni, Sofia" userId="0f006e73-fac7-47f0-8625-356df4b8922a" providerId="ADAL" clId="{2C0E25E5-DBE1-41EF-A810-7B452E6A22CA}" dt="2025-05-23T07:51:41.878" v="71" actId="1076"/>
          <ac:picMkLst>
            <pc:docMk/>
            <pc:sldMk cId="2649116898" sldId="258"/>
            <ac:picMk id="18" creationId="{6C3ACF6D-1824-DE95-8338-5B7B8E46EADF}"/>
          </ac:picMkLst>
        </pc:picChg>
        <pc:picChg chg="add mod">
          <ac:chgData name="Bengoa Luoni, Sofia" userId="0f006e73-fac7-47f0-8625-356df4b8922a" providerId="ADAL" clId="{2C0E25E5-DBE1-41EF-A810-7B452E6A22CA}" dt="2025-05-23T07:51:40.403" v="70" actId="1076"/>
          <ac:picMkLst>
            <pc:docMk/>
            <pc:sldMk cId="2649116898" sldId="258"/>
            <ac:picMk id="20" creationId="{31E3B8EF-2130-BAB1-FC2B-3B52FE3BDD4A}"/>
          </ac:picMkLst>
        </pc:picChg>
        <pc:picChg chg="add mod">
          <ac:chgData name="Bengoa Luoni, Sofia" userId="0f006e73-fac7-47f0-8625-356df4b8922a" providerId="ADAL" clId="{2C0E25E5-DBE1-41EF-A810-7B452E6A22CA}" dt="2025-05-23T07:51:57.605" v="75" actId="1076"/>
          <ac:picMkLst>
            <pc:docMk/>
            <pc:sldMk cId="2649116898" sldId="258"/>
            <ac:picMk id="22" creationId="{8B9646FB-3D61-1A00-2FB8-09E0877B92DD}"/>
          </ac:picMkLst>
        </pc:picChg>
        <pc:picChg chg="add mod">
          <ac:chgData name="Bengoa Luoni, Sofia" userId="0f006e73-fac7-47f0-8625-356df4b8922a" providerId="ADAL" clId="{2C0E25E5-DBE1-41EF-A810-7B452E6A22CA}" dt="2025-05-23T07:51:49.602" v="74" actId="1076"/>
          <ac:picMkLst>
            <pc:docMk/>
            <pc:sldMk cId="2649116898" sldId="258"/>
            <ac:picMk id="24" creationId="{755174BF-4495-5BD2-C033-C65C7B5812D3}"/>
          </ac:picMkLst>
        </pc:picChg>
        <pc:picChg chg="add mod">
          <ac:chgData name="Bengoa Luoni, Sofia" userId="0f006e73-fac7-47f0-8625-356df4b8922a" providerId="ADAL" clId="{2C0E25E5-DBE1-41EF-A810-7B452E6A22CA}" dt="2025-05-23T07:51:48.142" v="73" actId="1076"/>
          <ac:picMkLst>
            <pc:docMk/>
            <pc:sldMk cId="2649116898" sldId="258"/>
            <ac:picMk id="26" creationId="{C2547B63-1B73-678C-20C2-D4DCE14E37DC}"/>
          </ac:picMkLst>
        </pc:picChg>
      </pc:sldChg>
    </pc:docChg>
  </pc:docChgLst>
  <pc:docChgLst>
    <pc:chgData name="Bengoa Luoni, Sofia" userId="0f006e73-fac7-47f0-8625-356df4b8922a" providerId="ADAL" clId="{22AB9E20-885D-46E2-8376-B897CA17E291}"/>
    <pc:docChg chg="modSld">
      <pc:chgData name="Bengoa Luoni, Sofia" userId="0f006e73-fac7-47f0-8625-356df4b8922a" providerId="ADAL" clId="{22AB9E20-885D-46E2-8376-B897CA17E291}" dt="2025-07-10T09:54:10.147" v="7"/>
      <pc:docMkLst>
        <pc:docMk/>
      </pc:docMkLst>
      <pc:sldChg chg="addSp modSp mod">
        <pc:chgData name="Bengoa Luoni, Sofia" userId="0f006e73-fac7-47f0-8625-356df4b8922a" providerId="ADAL" clId="{22AB9E20-885D-46E2-8376-B897CA17E291}" dt="2025-07-10T09:54:03.432" v="6" actId="1076"/>
        <pc:sldMkLst>
          <pc:docMk/>
          <pc:sldMk cId="636206431" sldId="257"/>
        </pc:sldMkLst>
        <pc:graphicFrameChg chg="add mod modGraphic">
          <ac:chgData name="Bengoa Luoni, Sofia" userId="0f006e73-fac7-47f0-8625-356df4b8922a" providerId="ADAL" clId="{22AB9E20-885D-46E2-8376-B897CA17E291}" dt="2025-07-10T09:54:03.432" v="6" actId="1076"/>
          <ac:graphicFrameMkLst>
            <pc:docMk/>
            <pc:sldMk cId="636206431" sldId="257"/>
            <ac:graphicFrameMk id="2" creationId="{66F9D377-459D-256D-F2EC-A050EB4499BF}"/>
          </ac:graphicFrameMkLst>
        </pc:graphicFrameChg>
      </pc:sldChg>
      <pc:sldChg chg="addSp modSp">
        <pc:chgData name="Bengoa Luoni, Sofia" userId="0f006e73-fac7-47f0-8625-356df4b8922a" providerId="ADAL" clId="{22AB9E20-885D-46E2-8376-B897CA17E291}" dt="2025-07-10T09:54:10.147" v="7"/>
        <pc:sldMkLst>
          <pc:docMk/>
          <pc:sldMk cId="2649116898" sldId="258"/>
        </pc:sldMkLst>
        <pc:graphicFrameChg chg="add mod">
          <ac:chgData name="Bengoa Luoni, Sofia" userId="0f006e73-fac7-47f0-8625-356df4b8922a" providerId="ADAL" clId="{22AB9E20-885D-46E2-8376-B897CA17E291}" dt="2025-07-10T09:54:10.147" v="7"/>
          <ac:graphicFrameMkLst>
            <pc:docMk/>
            <pc:sldMk cId="2649116898" sldId="258"/>
            <ac:graphicFrameMk id="2" creationId="{2494AE39-A80F-83F0-31A0-79069CDCE954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DD495E8-0331-44A0-B76F-5E95BC89B4CA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EEDA35-A20F-4975-AF95-5D6D035B5F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8642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EEDA35-A20F-4975-AF95-5D6D035B5FD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67727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07CAA9-F83F-89FD-38D5-4A2E619CA1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FB7FD68-81D2-4444-A2B0-4638906EFF5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899894-CC84-6004-78EB-969160362F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A619-3C1E-4E94-8383-A5B9D8D855B8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CE4A06-51D3-E7AC-BC67-20A4CF309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64D743-CFAC-D891-AC3D-8412CCCFA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749DF-F7C4-49C2-86F7-CACC83B3D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534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C21C30-DEB6-5C06-BE50-145579F554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C1C8D6-BDF5-A97C-5768-88B9F8FA2D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20456F-B473-EDE9-70CB-5780B5DC36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A619-3C1E-4E94-8383-A5B9D8D855B8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48E706-9ACB-1D86-C438-B1877145BD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1B07AF-70F8-5140-ADBD-7A6B4DAA7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749DF-F7C4-49C2-86F7-CACC83B3D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555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A437E4C-4DE7-C30E-7E2C-E1D48B7D69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C790E8-5347-A613-324B-5DC6231B16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55BFBA-41A3-1EBA-5AC0-DADAA36E4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A619-3C1E-4E94-8383-A5B9D8D855B8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3C9AD2-81FB-94BB-A152-97681898E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64468E-1C2D-9DA7-E920-723882E234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749DF-F7C4-49C2-86F7-CACC83B3D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6875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93AA12-450F-1D41-4CE8-259D923DF0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C2EBB8-04A2-1B69-F6EE-30919846EF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146C7D-50CC-21F8-C250-A1A657E788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A619-3C1E-4E94-8383-A5B9D8D855B8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7256FE-99B0-C2DC-1F65-1C212D4C74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9790D5-69C1-91AF-6287-F44D0DB0BC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749DF-F7C4-49C2-86F7-CACC83B3D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727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88BDCD-9169-916E-99C2-20C5B0F574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A58DE3-CEE5-6922-C485-9AEFBB1C58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F5FD4D-7F5B-2B01-2E2C-F03549CB1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A619-3C1E-4E94-8383-A5B9D8D855B8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FB8D7F-992E-586E-EC75-C16978BC07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F5718F-E99D-9A59-5994-D47592935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749DF-F7C4-49C2-86F7-CACC83B3D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604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AFB7C0-1289-3458-C0BE-AC563DB5AE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D85674-9F20-E244-456A-F4A804075F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66CE94-D379-4857-8B02-73BDEBA1AE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8B20C9-ED6B-8BBC-EBD9-D554390FE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A619-3C1E-4E94-8383-A5B9D8D855B8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8031E1-FEB3-9F0F-EA43-73D9FB1852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86ADC2-6E6B-D4BF-F43F-268F3A147F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749DF-F7C4-49C2-86F7-CACC83B3D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16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C0BC8E-EE32-08BC-B54C-93430BBF8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64897C-E94B-357C-77B9-AF6D4B271F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700FAE-991D-7823-EEE1-CF47C6013C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1F041FC-4996-9E18-CD84-CB4F54B771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91987C-75F0-6890-004A-F37449B277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4712FE8-BF99-99D5-8C6A-0AFA3430A7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A619-3C1E-4E94-8383-A5B9D8D855B8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F95134-4EEF-D1DC-54F8-91667870C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17ED21B-589E-A1B2-BC8F-43CF919251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749DF-F7C4-49C2-86F7-CACC83B3D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4907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4113FF-4A97-F54E-883B-C294B25A7E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BB4F86D-D8CB-0E52-3001-25EACF8FA8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A619-3C1E-4E94-8383-A5B9D8D855B8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FD0361A-15B2-77BF-C4E5-73DEEAE07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E20483B-24BF-40B1-1EE0-D7237B9AC2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749DF-F7C4-49C2-86F7-CACC83B3D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638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67D2239-18F2-1126-835E-D75C850CB1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A619-3C1E-4E94-8383-A5B9D8D855B8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AAE59F2-2A67-FE37-8EE1-F2B3D996B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29673F8-5F84-6728-8FE0-D25056200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749DF-F7C4-49C2-86F7-CACC83B3D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588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6F50FA-0CD5-1A17-47C5-DFB0A6FC7B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410CD7-82B4-C381-93C9-36A441EAFE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BB213B-9D84-A18A-43E3-6360F30AA1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111A4E-A753-A663-A207-AB78DFB421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A619-3C1E-4E94-8383-A5B9D8D855B8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87413E-7F53-0D52-36E9-37E186709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1EBD05-580A-87A4-3255-4E789AF76D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749DF-F7C4-49C2-86F7-CACC83B3D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6261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2300C6-3BED-B8F1-EFAB-4AE472150E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D042AD4-FA0A-ADBC-0F5C-443C4F951E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A33328-0120-AD5B-927D-BC31FF9465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DC1D79-9FAB-D8B9-2E22-02C49E6EC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AA619-3C1E-4E94-8383-A5B9D8D855B8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B5E215-2D38-8E77-FADF-C34E0B0F0E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080092-D3DE-51E8-A750-927FC11F2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749DF-F7C4-49C2-86F7-CACC83B3D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318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4B5B493-FF7F-078B-116A-BF15F602C2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4DB504-94A6-AE39-BF1A-0E284FBB91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479D89-3ED7-33E8-CACC-3D79653EE4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DBAA619-3C1E-4E94-8383-A5B9D8D855B8}" type="datetimeFigureOut">
              <a:rPr lang="en-US" smtClean="0"/>
              <a:t>7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5C7FD0-3841-CE66-3150-F77034BC33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9C1602-914E-B3F1-AC72-55E1683055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54749DF-F7C4-49C2-86F7-CACC83B3D7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28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aph showing different colored lines&#10;&#10;AI-generated content may be incorrect.">
            <a:extLst>
              <a:ext uri="{FF2B5EF4-FFF2-40B4-BE49-F238E27FC236}">
                <a16:creationId xmlns:a16="http://schemas.microsoft.com/office/drawing/2014/main" id="{FFD56AC1-1F6D-BFBF-022D-D6D0BDEBEAA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0536" y="863438"/>
            <a:ext cx="3048000" cy="1828800"/>
          </a:xfrm>
          <a:prstGeom prst="rect">
            <a:avLst/>
          </a:prstGeom>
        </p:spPr>
      </p:pic>
      <p:pic>
        <p:nvPicPr>
          <p:cNvPr id="6" name="Picture 5" descr="A graph with different colored lines&#10;&#10;AI-generated content may be incorrect.">
            <a:extLst>
              <a:ext uri="{FF2B5EF4-FFF2-40B4-BE49-F238E27FC236}">
                <a16:creationId xmlns:a16="http://schemas.microsoft.com/office/drawing/2014/main" id="{056CAF1E-EE94-1A2C-5518-7607D7C3D10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5313" y="2859188"/>
            <a:ext cx="3048000" cy="1828800"/>
          </a:xfrm>
          <a:prstGeom prst="rect">
            <a:avLst/>
          </a:prstGeom>
        </p:spPr>
      </p:pic>
      <p:pic>
        <p:nvPicPr>
          <p:cNvPr id="8" name="Picture 7" descr="A graph with different colored lines&#10;&#10;AI-generated content may be incorrect.">
            <a:extLst>
              <a:ext uri="{FF2B5EF4-FFF2-40B4-BE49-F238E27FC236}">
                <a16:creationId xmlns:a16="http://schemas.microsoft.com/office/drawing/2014/main" id="{80FDA6A6-3E8A-64B0-35A3-FBD2F13FC50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5313" y="4854938"/>
            <a:ext cx="3048000" cy="1828800"/>
          </a:xfrm>
          <a:prstGeom prst="rect">
            <a:avLst/>
          </a:prstGeom>
        </p:spPr>
      </p:pic>
      <p:pic>
        <p:nvPicPr>
          <p:cNvPr id="16" name="Picture 15" descr="A graph showing different colored lines&#10;&#10;AI-generated content may be incorrect.">
            <a:extLst>
              <a:ext uri="{FF2B5EF4-FFF2-40B4-BE49-F238E27FC236}">
                <a16:creationId xmlns:a16="http://schemas.microsoft.com/office/drawing/2014/main" id="{515631D5-4341-1EDF-B2D2-66C26259620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28307" y="863438"/>
            <a:ext cx="3048000" cy="1828800"/>
          </a:xfrm>
          <a:prstGeom prst="rect">
            <a:avLst/>
          </a:prstGeom>
        </p:spPr>
      </p:pic>
      <p:pic>
        <p:nvPicPr>
          <p:cNvPr id="18" name="Picture 17" descr="A graph with different colored lines&#10;&#10;AI-generated content may be incorrect.">
            <a:extLst>
              <a:ext uri="{FF2B5EF4-FFF2-40B4-BE49-F238E27FC236}">
                <a16:creationId xmlns:a16="http://schemas.microsoft.com/office/drawing/2014/main" id="{6C3ACF6D-1824-DE95-8338-5B7B8E46EAD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28307" y="2859188"/>
            <a:ext cx="3048000" cy="1828800"/>
          </a:xfrm>
          <a:prstGeom prst="rect">
            <a:avLst/>
          </a:prstGeom>
        </p:spPr>
      </p:pic>
      <p:pic>
        <p:nvPicPr>
          <p:cNvPr id="20" name="Picture 19" descr="A graph showing different colored lines&#10;&#10;AI-generated content may be incorrect.">
            <a:extLst>
              <a:ext uri="{FF2B5EF4-FFF2-40B4-BE49-F238E27FC236}">
                <a16:creationId xmlns:a16="http://schemas.microsoft.com/office/drawing/2014/main" id="{31E3B8EF-2130-BAB1-FC2B-3B52FE3BDD4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28307" y="4854938"/>
            <a:ext cx="3048000" cy="1828800"/>
          </a:xfrm>
          <a:prstGeom prst="rect">
            <a:avLst/>
          </a:prstGeom>
        </p:spPr>
      </p:pic>
      <p:pic>
        <p:nvPicPr>
          <p:cNvPr id="22" name="Picture 21" descr="A graph with different colored lines&#10;&#10;AI-generated content may be incorrect.">
            <a:extLst>
              <a:ext uri="{FF2B5EF4-FFF2-40B4-BE49-F238E27FC236}">
                <a16:creationId xmlns:a16="http://schemas.microsoft.com/office/drawing/2014/main" id="{8B9646FB-3D61-1A00-2FB8-09E0877B92DD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8536" y="863438"/>
            <a:ext cx="3048000" cy="1828800"/>
          </a:xfrm>
          <a:prstGeom prst="rect">
            <a:avLst/>
          </a:prstGeom>
        </p:spPr>
      </p:pic>
      <p:pic>
        <p:nvPicPr>
          <p:cNvPr id="24" name="Picture 23" descr="A graph with different colored lines&#10;&#10;AI-generated content may be incorrect.">
            <a:extLst>
              <a:ext uri="{FF2B5EF4-FFF2-40B4-BE49-F238E27FC236}">
                <a16:creationId xmlns:a16="http://schemas.microsoft.com/office/drawing/2014/main" id="{755174BF-4495-5BD2-C033-C65C7B5812D3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3313" y="2859188"/>
            <a:ext cx="3048000" cy="1828800"/>
          </a:xfrm>
          <a:prstGeom prst="rect">
            <a:avLst/>
          </a:prstGeom>
        </p:spPr>
      </p:pic>
      <p:pic>
        <p:nvPicPr>
          <p:cNvPr id="26" name="Picture 25" descr="A graph showing the number of data&#10;&#10;AI-generated content may be incorrect.">
            <a:extLst>
              <a:ext uri="{FF2B5EF4-FFF2-40B4-BE49-F238E27FC236}">
                <a16:creationId xmlns:a16="http://schemas.microsoft.com/office/drawing/2014/main" id="{C2547B63-1B73-678C-20C2-D4DCE14E37DC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3313" y="4854938"/>
            <a:ext cx="3048000" cy="18288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1A6CA4C-A339-5FC9-39F4-F74FDA49A3CC}"/>
              </a:ext>
            </a:extLst>
          </p:cNvPr>
          <p:cNvSpPr txBox="1"/>
          <p:nvPr/>
        </p:nvSpPr>
        <p:spPr>
          <a:xfrm>
            <a:off x="83700" y="951928"/>
            <a:ext cx="2485065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Supplementary Material 4a.</a:t>
            </a:r>
            <a:r>
              <a:rPr lang="en-US" sz="1200" dirty="0"/>
              <a:t> </a:t>
            </a:r>
            <a:r>
              <a:rPr lang="en-US" sz="1200" i="1" dirty="0"/>
              <a:t>Low light experiment: Each graph shows Electron transport rate (ETR, y-axis) measured over time (x-axis) across different trays (Tray ID) for three species. Columns represent species: BNI (Brassica nigra), BRA (Brassica </a:t>
            </a:r>
            <a:r>
              <a:rPr lang="en-US" sz="1200" i="1" dirty="0" err="1"/>
              <a:t>rapa</a:t>
            </a:r>
            <a:r>
              <a:rPr lang="en-US" sz="1200" i="1" dirty="0"/>
              <a:t>), and HI (Hirschfeldia incana). Rows show data from two experimental days: October 26, October 28 and October 31, 2023.</a:t>
            </a:r>
            <a:endParaRPr lang="en-US" sz="1200" dirty="0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494AE39-A80F-83F0-31A0-79069CDCE9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641038"/>
              </p:ext>
            </p:extLst>
          </p:nvPr>
        </p:nvGraphicFramePr>
        <p:xfrm>
          <a:off x="44358" y="6053268"/>
          <a:ext cx="2529244" cy="6477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29244">
                  <a:extLst>
                    <a:ext uri="{9D8B030D-6E8A-4147-A177-3AD203B41FA5}">
                      <a16:colId xmlns:a16="http://schemas.microsoft.com/office/drawing/2014/main" val="3956951868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dding time-dimension to photosynthesis studies: a path towards linking biomass to photosynthesi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51681468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Sofia A. BENGOA LUONI &amp; Steven M. DRIEVE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5103944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491168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52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9772AC92-B40E-8A86-87D6-65DBFFD6A1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5275" y="909768"/>
            <a:ext cx="3048000" cy="1828800"/>
          </a:xfrm>
          <a:prstGeom prst="rect">
            <a:avLst/>
          </a:prstGeom>
        </p:spPr>
      </p:pic>
      <p:pic>
        <p:nvPicPr>
          <p:cNvPr id="55" name="Picture 54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C4D3F5A1-A61E-2D27-778D-48D738AAB59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5275" y="2890968"/>
            <a:ext cx="3048000" cy="1828800"/>
          </a:xfrm>
          <a:prstGeom prst="rect">
            <a:avLst/>
          </a:prstGeom>
        </p:spPr>
      </p:pic>
      <p:pic>
        <p:nvPicPr>
          <p:cNvPr id="57" name="Picture 56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6DECB1F6-6CCE-D0AE-B0C6-04F4D9300F4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5275" y="4872168"/>
            <a:ext cx="3048000" cy="1828800"/>
          </a:xfrm>
          <a:prstGeom prst="rect">
            <a:avLst/>
          </a:prstGeom>
        </p:spPr>
      </p:pic>
      <p:pic>
        <p:nvPicPr>
          <p:cNvPr id="59" name="Picture 58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315E27D0-E120-ADC4-53A7-4096E10C251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6622" y="794995"/>
            <a:ext cx="3048000" cy="1828800"/>
          </a:xfrm>
          <a:prstGeom prst="rect">
            <a:avLst/>
          </a:prstGeom>
        </p:spPr>
      </p:pic>
      <p:pic>
        <p:nvPicPr>
          <p:cNvPr id="61" name="Picture 60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8BC64586-FEDF-C21D-19E0-11A1F7A29B6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6622" y="2890968"/>
            <a:ext cx="3048000" cy="1828800"/>
          </a:xfrm>
          <a:prstGeom prst="rect">
            <a:avLst/>
          </a:prstGeom>
        </p:spPr>
      </p:pic>
      <p:pic>
        <p:nvPicPr>
          <p:cNvPr id="63" name="Picture 62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3E4F057E-FFEF-DF29-057C-9143B848AA6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6622" y="4872168"/>
            <a:ext cx="3048000" cy="1828800"/>
          </a:xfrm>
          <a:prstGeom prst="rect">
            <a:avLst/>
          </a:prstGeom>
        </p:spPr>
      </p:pic>
      <p:pic>
        <p:nvPicPr>
          <p:cNvPr id="65" name="Picture 64" descr="A graph of a graph&#10;&#10;AI-generated content may be incorrect.">
            <a:extLst>
              <a:ext uri="{FF2B5EF4-FFF2-40B4-BE49-F238E27FC236}">
                <a16:creationId xmlns:a16="http://schemas.microsoft.com/office/drawing/2014/main" id="{3E4B4DF0-29DD-8B7A-A419-B7AD5533D13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4703" y="794995"/>
            <a:ext cx="3048000" cy="1828800"/>
          </a:xfrm>
          <a:prstGeom prst="rect">
            <a:avLst/>
          </a:prstGeom>
        </p:spPr>
      </p:pic>
      <p:pic>
        <p:nvPicPr>
          <p:cNvPr id="67" name="Picture 66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02F78032-06D8-59CF-64D1-F94BD84FD7D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27969" y="2819071"/>
            <a:ext cx="3048000" cy="1828800"/>
          </a:xfrm>
          <a:prstGeom prst="rect">
            <a:avLst/>
          </a:prstGeom>
        </p:spPr>
      </p:pic>
      <p:pic>
        <p:nvPicPr>
          <p:cNvPr id="71" name="Picture 70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561A4C62-9D59-0ACC-8D5A-0BE94500B75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27969" y="4872168"/>
            <a:ext cx="3048000" cy="18288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B91AD48-56EB-9565-9291-100FE67E9656}"/>
              </a:ext>
            </a:extLst>
          </p:cNvPr>
          <p:cNvSpPr txBox="1"/>
          <p:nvPr/>
        </p:nvSpPr>
        <p:spPr>
          <a:xfrm>
            <a:off x="172385" y="909768"/>
            <a:ext cx="2329543" cy="24929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Supplementary Material 4b.</a:t>
            </a:r>
            <a:r>
              <a:rPr lang="en-US" sz="1200" dirty="0"/>
              <a:t> </a:t>
            </a:r>
            <a:r>
              <a:rPr lang="en-US" sz="1200" i="1" dirty="0"/>
              <a:t>High light experiment: Each graph shows Electron transport rate (ETR, y-axis) measured over time (x-axis) across different trays (Tray ID) for three species. Columns represent species: BNI (Brassica nigra), BRA (Brassica </a:t>
            </a:r>
            <a:r>
              <a:rPr lang="en-US" sz="1200" i="1" dirty="0" err="1"/>
              <a:t>rapa</a:t>
            </a:r>
            <a:r>
              <a:rPr lang="en-US" sz="1200" i="1" dirty="0"/>
              <a:t>), and HI (Hirschfeldia incana). Rows show data from two experimental days: October 26, October 28 and October 31, 2023.</a:t>
            </a:r>
            <a:endParaRPr lang="en-US" sz="1200" dirty="0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6F9D377-459D-256D-F2EC-A050EB4499B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1178185"/>
              </p:ext>
            </p:extLst>
          </p:nvPr>
        </p:nvGraphicFramePr>
        <p:xfrm>
          <a:off x="44358" y="6053268"/>
          <a:ext cx="2529244" cy="6477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29244">
                  <a:extLst>
                    <a:ext uri="{9D8B030D-6E8A-4147-A177-3AD203B41FA5}">
                      <a16:colId xmlns:a16="http://schemas.microsoft.com/office/drawing/2014/main" val="3956951868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dding time-dimension to photosynthesis studies: a path towards linking biomass to photosynthesi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51681468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Sofia A. BENGOA LUONI &amp; Steven M. DRIEVE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5103944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362064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</TotalTime>
  <Words>197</Words>
  <Application>Microsoft Office PowerPoint</Application>
  <PresentationFormat>Widescreen</PresentationFormat>
  <Paragraphs>7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ptos Narrow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ngoa Luoni, Sofia</dc:creator>
  <cp:lastModifiedBy>Bengoa Luoni, Sofia</cp:lastModifiedBy>
  <cp:revision>2</cp:revision>
  <dcterms:created xsi:type="dcterms:W3CDTF">2025-04-12T10:28:48Z</dcterms:created>
  <dcterms:modified xsi:type="dcterms:W3CDTF">2025-07-10T09:54:13Z</dcterms:modified>
</cp:coreProperties>
</file>